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6F133-C381-435B-9DC2-CC4DCA4496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7BDF7-D6D9-4093-871C-20DD192FE2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D29A7-D65C-4158-BA89-8A2EC4BF83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D0B07-AB07-4F5C-BD7F-9513FF6576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C508A-E5BB-46D4-A263-BF5ED8AE81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BFEAC-2816-43BF-9C60-968ABC638F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601F3-3778-4B5F-BCFB-7BE82B8B95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7DE59-6D7A-4A22-ADBF-5713EC3037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3E8B3-7DF3-4CC6-90A7-CF474F2B5F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03D09-2452-47EF-B66F-7F909871D0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6603B-7B77-40CF-9006-0BBF95FBB2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654B5-EA73-4627-AA8A-2ACAF1E36F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8B48C9-0C7A-464C-B6CC-829C5D7D093F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03120" y="1360440"/>
            <a:ext cx="6029280" cy="3613320"/>
            <a:chOff x="303120" y="1360440"/>
            <a:chExt cx="6029280" cy="3613320"/>
          </a:xfrm>
        </p:grpSpPr>
        <p:sp>
          <p:nvSpPr>
            <p:cNvPr id="42" name=""/>
            <p:cNvSpPr/>
            <p:nvPr/>
          </p:nvSpPr>
          <p:spPr>
            <a:xfrm>
              <a:off x="4535640" y="1549440"/>
              <a:ext cx="280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5934240" y="1522440"/>
              <a:ext cx="398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6200000">
              <a:off x="4437000" y="2113920"/>
              <a:ext cx="108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µm/d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321160" y="1898640"/>
              <a:ext cx="204840" cy="9097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673600" y="2058840"/>
              <a:ext cx="204840" cy="7495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024600" y="1789200"/>
              <a:ext cx="204840" cy="10191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flipV="1">
              <a:off x="5424480" y="1782360"/>
              <a:ext cx="1440" cy="120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402160" y="178920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5776920" y="1990800"/>
              <a:ext cx="1440" cy="69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753160" y="19954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6127920" y="1701720"/>
              <a:ext cx="1440" cy="92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102360" y="17049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99120" y="1579680"/>
              <a:ext cx="1440" cy="1222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153040" y="25160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153040" y="222732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153040" y="19400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194440" y="2800440"/>
              <a:ext cx="11188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071680" y="2725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071680" y="2441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071680" y="2152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071680" y="1862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231160" y="2844720"/>
              <a:ext cx="335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HA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651280" y="2844720"/>
              <a:ext cx="235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V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936400" y="2846520"/>
              <a:ext cx="357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U30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148360" y="28004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138640" y="1360440"/>
              <a:ext cx="23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484280" y="3419640"/>
              <a:ext cx="434196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Times New Roman"/>
                </a:rPr>
                <a:t>Figure S1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.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B2-specific agonist, HU-308, stimulates bone formation in mouse model for reversal of OVX</a:t>
              </a:r>
              <a:r>
                <a:rPr b="0" lang="he-IL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duced bone loss.</a:t>
              </a:r>
              <a:r>
                <a:rPr b="0" lang="he-IL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-B, trabecular parameters determined in distal femoral metaphysis. (A) mineral appositional rate; (B) bone formation rate; (C) endocortical mineral appositional rate determined in femoral diaphysis. SHAM, mice subjected to sham OVX only;VEH, mice treated only with solvent. Data are mean±SE obtained in 8 mice per condition. *p&lt; 0.05 vs. Sham and VEH; **p&lt;0.05 vs. VEH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266920" y="2635200"/>
              <a:ext cx="117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.18±0.10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" descr=""/>
            <p:cNvPicPr/>
            <p:nvPr/>
          </p:nvPicPr>
          <p:blipFill>
            <a:blip r:embed="rId1"/>
            <a:srcRect l="57374" t="44992" r="35659" b="45310"/>
            <a:stretch/>
          </p:blipFill>
          <p:spPr>
            <a:xfrm>
              <a:off x="1871640" y="2049480"/>
              <a:ext cx="617400" cy="61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"/>
            <p:cNvSpPr/>
            <p:nvPr/>
          </p:nvSpPr>
          <p:spPr>
            <a:xfrm>
              <a:off x="1265400" y="1825560"/>
              <a:ext cx="182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VE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92200" y="1811160"/>
              <a:ext cx="182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ha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" descr=""/>
            <p:cNvPicPr/>
            <p:nvPr/>
          </p:nvPicPr>
          <p:blipFill>
            <a:blip r:embed="rId2"/>
            <a:srcRect l="0" t="38249" r="57163" b="16931"/>
            <a:stretch/>
          </p:blipFill>
          <p:spPr>
            <a:xfrm>
              <a:off x="2541600" y="2050920"/>
              <a:ext cx="628560" cy="617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" descr=""/>
            <p:cNvPicPr/>
            <p:nvPr/>
          </p:nvPicPr>
          <p:blipFill>
            <a:blip r:embed="rId3"/>
            <a:srcRect l="47823" t="39732" r="45227" b="50371"/>
            <a:stretch/>
          </p:blipFill>
          <p:spPr>
            <a:xfrm>
              <a:off x="1198440" y="2048040"/>
              <a:ext cx="615960" cy="63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>
              <a:off x="1519200" y="2387520"/>
              <a:ext cx="65160" cy="3492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631960" y="2360520"/>
              <a:ext cx="104760" cy="5724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2626200" y="2339280"/>
              <a:ext cx="17640" cy="4608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H="1">
              <a:off x="2723040" y="2394720"/>
              <a:ext cx="18000" cy="4464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1571400" y="2401920"/>
              <a:ext cx="28440" cy="4608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1506240" y="2362320"/>
              <a:ext cx="28440" cy="4608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840040" y="2641680"/>
              <a:ext cx="309600" cy="0"/>
            </a:xfrm>
            <a:prstGeom prst="line">
              <a:avLst/>
            </a:prstGeom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776680" y="2471760"/>
              <a:ext cx="436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ffffff"/>
                  </a:solidFill>
                  <a:latin typeface="Arial"/>
                </a:rPr>
                <a:t>5µ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941480" y="1825560"/>
              <a:ext cx="182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U-30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917640" y="2638440"/>
              <a:ext cx="117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84±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592280" y="2638440"/>
              <a:ext cx="117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96±0.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03120" y="2630520"/>
              <a:ext cx="936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AR (µm/day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079640" y="1619280"/>
              <a:ext cx="27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109960" y="2341440"/>
              <a:ext cx="99720" cy="5076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2102400" y="2321640"/>
              <a:ext cx="18000" cy="4608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H="1">
              <a:off x="2196000" y="2369160"/>
              <a:ext cx="18000" cy="44640"/>
            </a:xfrm>
            <a:prstGeom prst="line">
              <a:avLst/>
            </a:prstGeom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570560" y="1784520"/>
              <a:ext cx="204480" cy="10270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192560" y="1925640"/>
              <a:ext cx="204840" cy="8859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840120" y="1979640"/>
              <a:ext cx="204840" cy="8319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4673520" y="1733400"/>
              <a:ext cx="0" cy="51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646520" y="1730520"/>
              <a:ext cx="5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4295880" y="1895400"/>
              <a:ext cx="0" cy="30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270320" y="1892160"/>
              <a:ext cx="5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3943440" y="1966680"/>
              <a:ext cx="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17880" y="1962000"/>
              <a:ext cx="5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706920" y="1582560"/>
              <a:ext cx="0" cy="1227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656160" y="281160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656160" y="254016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656160" y="227340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656160" y="20066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656160" y="17384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706920" y="2811600"/>
              <a:ext cx="1104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565080" y="2732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56720" y="24638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565080" y="2195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456720" y="19288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565080" y="1660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466160" y="2844720"/>
              <a:ext cx="389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U308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171680" y="2844720"/>
              <a:ext cx="235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V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765960" y="2844720"/>
              <a:ext cx="335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HA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6200000">
              <a:off x="2733840" y="2073240"/>
              <a:ext cx="130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m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/mm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/d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679920" y="1360440"/>
              <a:ext cx="19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"/>
          <p:cNvSpPr/>
          <p:nvPr/>
        </p:nvSpPr>
        <p:spPr>
          <a:xfrm>
            <a:off x="2527200" y="865080"/>
            <a:ext cx="17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"/>
          <p:cNvGrpSpPr/>
          <p:nvPr/>
        </p:nvGrpSpPr>
        <p:grpSpPr>
          <a:xfrm>
            <a:off x="585720" y="468360"/>
            <a:ext cx="5796000" cy="8345520"/>
            <a:chOff x="585720" y="468360"/>
            <a:chExt cx="5796000" cy="8345520"/>
          </a:xfrm>
        </p:grpSpPr>
        <p:sp>
          <p:nvSpPr>
            <p:cNvPr id="119" name=""/>
            <p:cNvSpPr/>
            <p:nvPr/>
          </p:nvSpPr>
          <p:spPr>
            <a:xfrm rot="16200000">
              <a:off x="159480" y="4915080"/>
              <a:ext cx="136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Q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59"/>
            <p:cNvSpPr/>
            <p:nvPr/>
          </p:nvSpPr>
          <p:spPr>
            <a:xfrm>
              <a:off x="1728720" y="6334200"/>
              <a:ext cx="1271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99"/>
            <p:cNvSpPr/>
            <p:nvPr/>
          </p:nvSpPr>
          <p:spPr>
            <a:xfrm>
              <a:off x="1461960" y="6340320"/>
              <a:ext cx="1805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0126 (µM)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27"/>
            <p:cNvSpPr/>
            <p:nvPr/>
          </p:nvSpPr>
          <p:spPr>
            <a:xfrm>
              <a:off x="2055960" y="44370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19"/>
            <p:cNvSpPr/>
            <p:nvPr/>
          </p:nvSpPr>
          <p:spPr>
            <a:xfrm>
              <a:off x="1791360" y="3792600"/>
              <a:ext cx="1166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</a:rPr>
                <a:t>-8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M HU-30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127"/>
            <p:cNvSpPr/>
            <p:nvPr/>
          </p:nvSpPr>
          <p:spPr>
            <a:xfrm>
              <a:off x="1733760" y="39895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084680" y="376884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417680" y="5237280"/>
              <a:ext cx="247680" cy="8571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746360" y="4502160"/>
              <a:ext cx="241200" cy="15922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070000" y="4686480"/>
              <a:ext cx="247680" cy="14079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406600" y="5530680"/>
              <a:ext cx="246240" cy="5637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738520" y="5506920"/>
              <a:ext cx="245880" cy="58752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1541520" y="5192640"/>
              <a:ext cx="0" cy="44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523880" y="519264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1866960" y="4201920"/>
              <a:ext cx="0" cy="299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849320" y="420228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193840" y="4649760"/>
              <a:ext cx="0" cy="36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176560" y="4649760"/>
              <a:ext cx="36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530440" y="5506920"/>
              <a:ext cx="0" cy="23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511360" y="550692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2862360" y="5478120"/>
              <a:ext cx="0" cy="28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843280" y="547848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265400" y="4035600"/>
              <a:ext cx="0" cy="2058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214280" y="609444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214280" y="540540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214280" y="472284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214280" y="403560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265400" y="6099120"/>
              <a:ext cx="1846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077840" y="6016680"/>
              <a:ext cx="50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010520" y="53276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010520" y="46465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010520" y="39560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59"/>
            <p:cNvSpPr/>
            <p:nvPr/>
          </p:nvSpPr>
          <p:spPr>
            <a:xfrm>
              <a:off x="1738440" y="4024440"/>
              <a:ext cx="1271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465200" y="6149880"/>
              <a:ext cx="13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829880" y="6149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152440" y="6149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491920" y="6149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798280" y="6149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928800" y="7164360"/>
              <a:ext cx="5452920" cy="164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Times New Roman"/>
                </a:rPr>
                <a:t>Figure S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Effect of MAP Kinase inhibitors on NeMCO number (A-B) and MC3T3 E1 mRNA expression (C-D). A, C, D,  MEK/Erk1/2 inhibitor U0126. B, p38 inhibitor SB202190. C, Mapkapk2. D, Cyclin D1. Cell counts were determined in cultures incubated for 48 h with or without HU-308 and the indicated doses of inhibitors, 3 culture wells per condition. Real-time RT-PCR analysis was carried out in 6 culture dishes per condition after 5-hour incubation with HU-308 and the indicated doses of inhibitors. Data are mean±SE. *p&lt; 0.05 vs. Ct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 rtl="1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14"/>
            <p:cNvSpPr/>
            <p:nvPr/>
          </p:nvSpPr>
          <p:spPr>
            <a:xfrm>
              <a:off x="1998720" y="9190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114"/>
            <p:cNvSpPr/>
            <p:nvPr/>
          </p:nvSpPr>
          <p:spPr>
            <a:xfrm>
              <a:off x="1692360" y="8478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25"/>
            <p:cNvSpPr/>
            <p:nvPr/>
          </p:nvSpPr>
          <p:spPr>
            <a:xfrm>
              <a:off x="1956240" y="3071880"/>
              <a:ext cx="99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0126 (μ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18"/>
            <p:cNvSpPr/>
            <p:nvPr/>
          </p:nvSpPr>
          <p:spPr>
            <a:xfrm>
              <a:off x="1706400" y="763560"/>
              <a:ext cx="1541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119"/>
            <p:cNvSpPr/>
            <p:nvPr/>
          </p:nvSpPr>
          <p:spPr>
            <a:xfrm>
              <a:off x="1889280" y="469800"/>
              <a:ext cx="11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</a:rPr>
                <a:t>-8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M HU-30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18"/>
            <p:cNvSpPr/>
            <p:nvPr/>
          </p:nvSpPr>
          <p:spPr>
            <a:xfrm>
              <a:off x="1695600" y="3095640"/>
              <a:ext cx="1517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090800" y="53640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386000" y="2077920"/>
              <a:ext cx="255600" cy="8002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701720" y="1114560"/>
              <a:ext cx="244440" cy="176364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009880" y="1163520"/>
              <a:ext cx="255600" cy="17146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325600" y="1633680"/>
              <a:ext cx="244440" cy="12445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631960" y="1927080"/>
              <a:ext cx="255600" cy="951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952720" y="2130480"/>
              <a:ext cx="244440" cy="7477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1508040" y="2039760"/>
              <a:ext cx="0" cy="38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479600" y="20397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1824120" y="1072800"/>
              <a:ext cx="0" cy="41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1798560" y="10731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2131920" y="113832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2106720" y="113832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2448000" y="1607760"/>
              <a:ext cx="0" cy="25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421000" y="160812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2759040" y="1903320"/>
              <a:ext cx="0" cy="23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733840" y="190332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3075120" y="2090880"/>
              <a:ext cx="0" cy="3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3048120" y="20908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266840" y="822240"/>
              <a:ext cx="0" cy="205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220760" y="287820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220760" y="253512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220760" y="21956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220760" y="185112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220760" y="150660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220760" y="116352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1220760" y="822240"/>
              <a:ext cx="50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1107720" y="2808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830880" y="24606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830880" y="21160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830880" y="17733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3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830880" y="143352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830880" y="10890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830880" y="74772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441440" y="2922480"/>
              <a:ext cx="13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78704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09988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40624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2690280" y="2922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006360" y="2922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rot="16200000">
              <a:off x="349560" y="1757520"/>
              <a:ext cx="65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ells No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04"/>
            <p:cNvSpPr/>
            <p:nvPr/>
          </p:nvSpPr>
          <p:spPr>
            <a:xfrm>
              <a:off x="1257480" y="2879640"/>
              <a:ext cx="1987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114"/>
            <p:cNvSpPr/>
            <p:nvPr/>
          </p:nvSpPr>
          <p:spPr>
            <a:xfrm>
              <a:off x="2313360" y="13971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56"/>
            <p:cNvSpPr/>
            <p:nvPr/>
          </p:nvSpPr>
          <p:spPr>
            <a:xfrm>
              <a:off x="4815720" y="3119400"/>
              <a:ext cx="1082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B202190 (µ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59"/>
            <p:cNvSpPr/>
            <p:nvPr/>
          </p:nvSpPr>
          <p:spPr>
            <a:xfrm>
              <a:off x="4518000" y="3097080"/>
              <a:ext cx="1677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172040" y="2063880"/>
              <a:ext cx="255600" cy="7966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521240" y="1182600"/>
              <a:ext cx="255600" cy="167796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871880" y="1069920"/>
              <a:ext cx="265320" cy="179064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230800" y="1084320"/>
              <a:ext cx="255600" cy="177624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586480" y="1152360"/>
              <a:ext cx="253800" cy="170820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937120" y="1198440"/>
              <a:ext cx="252720" cy="166212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4300560" y="2035080"/>
              <a:ext cx="0" cy="28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275000" y="20350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4648320" y="1109160"/>
              <a:ext cx="0" cy="73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624560" y="110952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4997520" y="958320"/>
              <a:ext cx="0" cy="111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971960" y="9586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5357880" y="931680"/>
              <a:ext cx="0" cy="15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334120" y="93204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5713560" y="1027080"/>
              <a:ext cx="0" cy="125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688000" y="10270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6060960" y="974520"/>
              <a:ext cx="0" cy="223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6037200" y="9748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078440" y="804960"/>
              <a:ext cx="0" cy="2055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025880" y="28749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025880" y="254160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025880" y="21891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025880" y="185724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025880" y="150480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025880" y="11685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025880" y="82080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078440" y="2874960"/>
              <a:ext cx="2222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916080" y="2800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3636000" y="24652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636000" y="21128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636000" y="17780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3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636000" y="14288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3636000" y="10922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3636000" y="7444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4230720" y="2922480"/>
              <a:ext cx="13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60980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96368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5312880" y="2922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5638320" y="2922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5987520" y="2922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rot="16200000">
              <a:off x="3202200" y="1740960"/>
              <a:ext cx="65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ells No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897720" y="53820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118"/>
            <p:cNvSpPr/>
            <p:nvPr/>
          </p:nvSpPr>
          <p:spPr>
            <a:xfrm>
              <a:off x="4470480" y="765000"/>
              <a:ext cx="1770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 Box 119"/>
            <p:cNvSpPr/>
            <p:nvPr/>
          </p:nvSpPr>
          <p:spPr>
            <a:xfrm>
              <a:off x="4765680" y="468360"/>
              <a:ext cx="117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</a:rPr>
                <a:t>-8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M HU-30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 Box 114"/>
            <p:cNvSpPr/>
            <p:nvPr/>
          </p:nvSpPr>
          <p:spPr>
            <a:xfrm>
              <a:off x="5926320" y="7524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Text Box 114"/>
            <p:cNvSpPr/>
            <p:nvPr/>
          </p:nvSpPr>
          <p:spPr>
            <a:xfrm>
              <a:off x="5577120" y="8049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Text Box 114"/>
            <p:cNvSpPr/>
            <p:nvPr/>
          </p:nvSpPr>
          <p:spPr>
            <a:xfrm>
              <a:off x="5221440" y="71604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 Box 114"/>
            <p:cNvSpPr/>
            <p:nvPr/>
          </p:nvSpPr>
          <p:spPr>
            <a:xfrm>
              <a:off x="4861080" y="7398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Text Box 114"/>
            <p:cNvSpPr/>
            <p:nvPr/>
          </p:nvSpPr>
          <p:spPr>
            <a:xfrm>
              <a:off x="4513320" y="8920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856320" y="376884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Text Box 125"/>
            <p:cNvSpPr/>
            <p:nvPr/>
          </p:nvSpPr>
          <p:spPr>
            <a:xfrm>
              <a:off x="4522320" y="6294600"/>
              <a:ext cx="99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0126 (µ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 Box 209"/>
            <p:cNvSpPr/>
            <p:nvPr/>
          </p:nvSpPr>
          <p:spPr>
            <a:xfrm rot="16200000">
              <a:off x="2540880" y="4977360"/>
              <a:ext cx="2131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Q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103640" y="5421240"/>
              <a:ext cx="216000" cy="68904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365720" y="4402080"/>
              <a:ext cx="215640" cy="170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626000" y="4491000"/>
              <a:ext cx="216000" cy="1619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888080" y="4491000"/>
              <a:ext cx="215640" cy="1619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5157720" y="5421240"/>
              <a:ext cx="216000" cy="6890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5427720" y="5253120"/>
              <a:ext cx="216000" cy="8571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flipV="1">
              <a:off x="4211640" y="5316120"/>
              <a:ext cx="144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186080" y="531648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flipV="1">
              <a:off x="4473720" y="4325760"/>
              <a:ext cx="1440" cy="763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446720" y="432576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V="1">
              <a:off x="4734000" y="4377960"/>
              <a:ext cx="1440" cy="112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707000" y="437832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4995720" y="4467240"/>
              <a:ext cx="1800" cy="23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970520" y="446724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5265720" y="5384520"/>
              <a:ext cx="1440" cy="36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240160" y="5384880"/>
              <a:ext cx="51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H="1" flipV="1">
              <a:off x="5535720" y="5135400"/>
              <a:ext cx="1440" cy="115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5510160" y="513540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025880" y="4037040"/>
              <a:ext cx="1440" cy="2073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975120" y="61102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975120" y="542124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3975120" y="472428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975120" y="4037040"/>
              <a:ext cx="50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025880" y="6110280"/>
              <a:ext cx="1708200" cy="6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812760" y="60357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771360" y="53467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771360" y="4651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3771360" y="39625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695840" y="4092480"/>
              <a:ext cx="14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695840" y="4092480"/>
              <a:ext cx="14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Text Box 119"/>
            <p:cNvSpPr/>
            <p:nvPr/>
          </p:nvSpPr>
          <p:spPr>
            <a:xfrm>
              <a:off x="4385160" y="3792600"/>
              <a:ext cx="1166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</a:rPr>
                <a:t>-8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M HU-30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18"/>
            <p:cNvSpPr/>
            <p:nvPr/>
          </p:nvSpPr>
          <p:spPr>
            <a:xfrm>
              <a:off x="4351320" y="4025880"/>
              <a:ext cx="1301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118"/>
            <p:cNvSpPr/>
            <p:nvPr/>
          </p:nvSpPr>
          <p:spPr>
            <a:xfrm>
              <a:off x="4365720" y="6335640"/>
              <a:ext cx="1301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135320" y="6151680"/>
              <a:ext cx="13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438440" y="6151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701960" y="6151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960440" y="6151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196960" y="6151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5470200" y="6151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Text Box 127"/>
            <p:cNvSpPr/>
            <p:nvPr/>
          </p:nvSpPr>
          <p:spPr>
            <a:xfrm>
              <a:off x="4596120" y="41655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Text Box 127"/>
            <p:cNvSpPr/>
            <p:nvPr/>
          </p:nvSpPr>
          <p:spPr>
            <a:xfrm>
              <a:off x="4338720" y="41148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 Box 127"/>
            <p:cNvSpPr/>
            <p:nvPr/>
          </p:nvSpPr>
          <p:spPr>
            <a:xfrm>
              <a:off x="4857840" y="42544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V="1">
              <a:off x="150804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flipV="1">
              <a:off x="182088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 flipV="1">
              <a:off x="213984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 flipV="1">
              <a:off x="244800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flipV="1">
              <a:off x="276372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 flipV="1">
              <a:off x="3078000" y="288108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flipV="1">
              <a:off x="1533600" y="61005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 flipV="1">
              <a:off x="1865160" y="61005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flipV="1">
              <a:off x="2197080" y="61005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flipV="1">
              <a:off x="2527200" y="61005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flipV="1">
              <a:off x="2859120" y="61005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flipV="1">
              <a:off x="4208400" y="611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flipV="1">
              <a:off x="4478400" y="611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flipV="1">
              <a:off x="4730760" y="611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flipV="1">
              <a:off x="4994280" y="611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flipV="1">
              <a:off x="5261040" y="611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5541840" y="61113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flipV="1">
              <a:off x="4297320" y="28713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V="1">
              <a:off x="464328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 flipV="1">
              <a:off x="499752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flipV="1">
              <a:off x="535140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 flipV="1">
              <a:off x="5711760" y="287460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flipV="1">
              <a:off x="6060960" y="2873160"/>
              <a:ext cx="0" cy="34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6" name=""/>
          <p:cNvSpPr/>
          <p:nvPr/>
        </p:nvSpPr>
        <p:spPr>
          <a:xfrm>
            <a:off x="2527200" y="88920"/>
            <a:ext cx="17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Supplemental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4T18:03:06Z</dcterms:created>
  <dc:creator> </dc:creator>
  <dc:description/>
  <dc:language>en-US</dc:language>
  <cp:lastModifiedBy>orro</cp:lastModifiedBy>
  <dcterms:modified xsi:type="dcterms:W3CDTF">2010-07-22T06:43:44Z</dcterms:modified>
  <cp:revision>221</cp:revision>
  <dc:subject/>
  <dc:title>Slide 1</dc:title>
</cp:coreProperties>
</file>